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698F-42A4-9F75-8FA2E8247450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698F-42A4-9F75-8FA2E8247450}"/>
              </c:ext>
            </c:extLst>
          </c:dPt>
          <c:dLbls>
            <c:dLbl>
              <c:idx val="0"/>
              <c:layout>
                <c:manualLayout>
                  <c:x val="-1.9123866254892253E-2"/>
                  <c:y val="0.1458859052248481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698F-42A4-9F75-8FA2E8247450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698F-42A4-9F75-8FA2E824745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I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남녀_2015_I!$B$1:$B$2</c:f>
              <c:numCache>
                <c:formatCode>General</c:formatCode>
                <c:ptCount val="2"/>
                <c:pt idx="0">
                  <c:v>99.6</c:v>
                </c:pt>
                <c:pt idx="1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98F-42A4-9F75-8FA2E8247450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4989-438E-9446-BBA986D3023B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4989-438E-9446-BBA986D3023B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4989-438E-9446-BBA986D3023B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FB5C3BA5-E124-41DF-B720-E2ADB53DBE1E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989-438E-9446-BBA986D3023B}"/>
                </c:ext>
              </c:extLst>
            </c:dLbl>
            <c:dLbl>
              <c:idx val="1"/>
              <c:layout>
                <c:manualLayout>
                  <c:x val="-3.1235841823641673E-2"/>
                  <c:y val="0.10793324423426198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989-438E-9446-BBA986D3023B}"/>
                </c:ext>
              </c:extLst>
            </c:dLbl>
            <c:dLbl>
              <c:idx val="2"/>
              <c:layout>
                <c:manualLayout>
                  <c:x val="-4.2464094434796215E-3"/>
                  <c:y val="1.1358481641068738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989-438E-9446-BBA986D3023B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I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남녀_2015_I!$B$5:$B$7</c:f>
              <c:numCache>
                <c:formatCode>General</c:formatCode>
                <c:ptCount val="3"/>
                <c:pt idx="0">
                  <c:v>658</c:v>
                </c:pt>
                <c:pt idx="1">
                  <c:v>173</c:v>
                </c:pt>
                <c:pt idx="2">
                  <c:v>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989-438E-9446-BBA986D3023B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DC66-4464-ACA0-FB939DF8BF4C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DC66-4464-ACA0-FB939DF8BF4C}"/>
              </c:ext>
            </c:extLst>
          </c:dPt>
          <c:dLbls>
            <c:dLbl>
              <c:idx val="0"/>
              <c:layout>
                <c:manualLayout>
                  <c:x val="-1.6696991912530601E-2"/>
                  <c:y val="2.0471340573188536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b="1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C66-4464-ACA0-FB939DF8BF4C}"/>
                </c:ext>
              </c:extLst>
            </c:dLbl>
            <c:dLbl>
              <c:idx val="1"/>
              <c:layout>
                <c:manualLayout>
                  <c:x val="-9.0868831934773908E-3"/>
                  <c:y val="5.4020903679218579E-3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657050917255576"/>
                      <c:h val="0.13863249968033567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C66-4464-ACA0-FB939DF8BF4C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I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남자_2015_I!$B$1:$B$2</c:f>
              <c:numCache>
                <c:formatCode>General</c:formatCode>
                <c:ptCount val="2"/>
                <c:pt idx="0">
                  <c:v>99.7</c:v>
                </c:pt>
                <c:pt idx="1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C66-4464-ACA0-FB939DF8BF4C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3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A8EF-4478-97BC-0AB45946AB17}"/>
              </c:ext>
            </c:extLst>
          </c:dPt>
          <c:dLbls>
            <c:dLbl>
              <c:idx val="0"/>
              <c:layout>
                <c:manualLayout>
                  <c:x val="0.2578697370041575"/>
                  <c:y val="-4.2884858120300677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A3FE1561-3EAD-41AB-BD00-C6F90790CAA7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A8EF-4478-97BC-0AB45946AB1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I!$A$5</c:f>
              <c:strCache>
                <c:ptCount val="1"/>
                <c:pt idx="0">
                  <c:v>Colorectal</c:v>
                </c:pt>
              </c:strCache>
            </c:strRef>
          </c:cat>
          <c:val>
            <c:numRef>
              <c:f>남자_2015_I!$B$5</c:f>
              <c:numCache>
                <c:formatCode>General</c:formatCode>
                <c:ptCount val="1"/>
                <c:pt idx="0">
                  <c:v>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EF-4478-97BC-0AB45946AB17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DECB-44A0-A8E0-2FD7511D5CB8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DECB-44A0-A8E0-2FD7511D5CB8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ECB-44A0-A8E0-2FD7511D5CB8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155922444251517"/>
                      <c:h val="0.1318899531563354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ECB-44A0-A8E0-2FD7511D5CB8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I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여자_2015_I!$B$1:$B$2</c:f>
              <c:numCache>
                <c:formatCode>General</c:formatCode>
                <c:ptCount val="2"/>
                <c:pt idx="0">
                  <c:v>99.4</c:v>
                </c:pt>
                <c:pt idx="1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CB-44A0-A8E0-2FD7511D5CB8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E51-4D1B-A041-7BBBA9C3C9A6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E51-4D1B-A041-7BBBA9C3C9A6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2E51-4D1B-A041-7BBBA9C3C9A6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D9FDD48B-1BD8-481F-AFCC-9569A4C021F3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E51-4D1B-A041-7BBBA9C3C9A6}"/>
                </c:ext>
              </c:extLst>
            </c:dLbl>
            <c:dLbl>
              <c:idx val="1"/>
              <c:layout>
                <c:manualLayout>
                  <c:x val="6.8669496472505247E-3"/>
                  <c:y val="-8.503952754091505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E51-4D1B-A041-7BBBA9C3C9A6}"/>
                </c:ext>
              </c:extLst>
            </c:dLbl>
            <c:dLbl>
              <c:idx val="2"/>
              <c:layout>
                <c:manualLayout>
                  <c:x val="-2.9655852010293148E-2"/>
                  <c:y val="-1.557482600713696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E51-4D1B-A041-7BBBA9C3C9A6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I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여자_2015_I!$B$5:$B$7</c:f>
              <c:numCache>
                <c:formatCode>General</c:formatCode>
                <c:ptCount val="3"/>
                <c:pt idx="0">
                  <c:v>355</c:v>
                </c:pt>
                <c:pt idx="1">
                  <c:v>173</c:v>
                </c:pt>
                <c:pt idx="2">
                  <c:v>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E51-4D1B-A041-7BBBA9C3C9A6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184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711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35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6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2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2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6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65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32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248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0C01379C-B2A3-4025-8600-76A773580210}"/>
              </a:ext>
            </a:extLst>
          </p:cNvPr>
          <p:cNvGrpSpPr/>
          <p:nvPr/>
        </p:nvGrpSpPr>
        <p:grpSpPr>
          <a:xfrm>
            <a:off x="486390" y="154203"/>
            <a:ext cx="5758220" cy="9573682"/>
            <a:chOff x="407645" y="423574"/>
            <a:chExt cx="5758220" cy="9573682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471555" y="9443258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7. The population attributable fraction (%) of cancer cases attributed to deficit in physical activity and proportion of specific cancers among all-cancer cases caused by deficit in physical activity in Korea, 2015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9AA981CF-3030-4B4F-9B69-616A297DAEAE}"/>
                </a:ext>
              </a:extLst>
            </p:cNvPr>
            <p:cNvGrpSpPr/>
            <p:nvPr/>
          </p:nvGrpSpPr>
          <p:grpSpPr>
            <a:xfrm>
              <a:off x="407645" y="423574"/>
              <a:ext cx="5758220" cy="9016956"/>
              <a:chOff x="515253" y="423574"/>
              <a:chExt cx="5758220" cy="9016956"/>
            </a:xfrm>
          </p:grpSpPr>
          <p:grpSp>
            <p:nvGrpSpPr>
              <p:cNvPr id="6" name="그룹 5">
                <a:extLst>
                  <a:ext uri="{FF2B5EF4-FFF2-40B4-BE49-F238E27FC236}">
                    <a16:creationId xmlns:a16="http://schemas.microsoft.com/office/drawing/2014/main" id="{A22E606B-21E5-4343-AF0B-48F83F322F65}"/>
                  </a:ext>
                </a:extLst>
              </p:cNvPr>
              <p:cNvGrpSpPr/>
              <p:nvPr/>
            </p:nvGrpSpPr>
            <p:grpSpPr>
              <a:xfrm>
                <a:off x="515253" y="423574"/>
                <a:ext cx="5721797" cy="3040019"/>
                <a:chOff x="515253" y="423574"/>
                <a:chExt cx="5721797" cy="3040019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3" y="587120"/>
                  <a:ext cx="15055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2" name="그룹 51">
                  <a:extLst>
                    <a:ext uri="{FF2B5EF4-FFF2-40B4-BE49-F238E27FC236}">
                      <a16:creationId xmlns:a16="http://schemas.microsoft.com/office/drawing/2014/main" id="{76232BF6-AA59-4DCD-AB33-BC436025137B}"/>
                    </a:ext>
                  </a:extLst>
                </p:cNvPr>
                <p:cNvGrpSpPr/>
                <p:nvPr/>
              </p:nvGrpSpPr>
              <p:grpSpPr>
                <a:xfrm>
                  <a:off x="541937" y="423574"/>
                  <a:ext cx="5695113" cy="3040019"/>
                  <a:chOff x="0" y="0"/>
                  <a:chExt cx="5674093" cy="2889196"/>
                </a:xfrm>
              </p:grpSpPr>
              <p:grpSp>
                <p:nvGrpSpPr>
                  <p:cNvPr id="54" name="그룹 53">
                    <a:extLst>
                      <a:ext uri="{FF2B5EF4-FFF2-40B4-BE49-F238E27FC236}">
                        <a16:creationId xmlns:a16="http://schemas.microsoft.com/office/drawing/2014/main" id="{DDF017FE-B798-4D73-8650-96CE0FA15CD2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674093" cy="2889196"/>
                    <a:chOff x="0" y="0"/>
                    <a:chExt cx="6113798" cy="3579573"/>
                  </a:xfrm>
                </p:grpSpPr>
                <p:grpSp>
                  <p:nvGrpSpPr>
                    <p:cNvPr id="56" name="그룹 55">
                      <a:extLst>
                        <a:ext uri="{FF2B5EF4-FFF2-40B4-BE49-F238E27FC236}">
                          <a16:creationId xmlns:a16="http://schemas.microsoft.com/office/drawing/2014/main" id="{3853C272-4590-4433-B59D-BB4EA5C2FCB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58" name="차트 57">
                        <a:extLst>
                          <a:ext uri="{FF2B5EF4-FFF2-40B4-BE49-F238E27FC236}">
                            <a16:creationId xmlns:a16="http://schemas.microsoft.com/office/drawing/2014/main" id="{89586AE1-FE79-4DB0-8552-B5548F0EDABE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59" name="차트 58">
                        <a:extLst>
                          <a:ext uri="{FF2B5EF4-FFF2-40B4-BE49-F238E27FC236}">
                            <a16:creationId xmlns:a16="http://schemas.microsoft.com/office/drawing/2014/main" id="{9D49CD8C-4A15-4622-904A-265C66540896}"/>
                          </a:ext>
                        </a:extLst>
                      </p:cNvPr>
                      <p:cNvGraphicFramePr>
                        <a:graphicFrameLocks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1795912462"/>
                          </p:ext>
                        </p:extLst>
                      </p:nvPr>
                    </p:nvGraphicFramePr>
                    <p:xfrm>
                      <a:off x="5273414" y="0"/>
                      <a:ext cx="5831908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57" name="직선 연결선 56">
                      <a:extLst>
                        <a:ext uri="{FF2B5EF4-FFF2-40B4-BE49-F238E27FC236}">
                          <a16:creationId xmlns:a16="http://schemas.microsoft.com/office/drawing/2014/main" id="{E847E715-63AF-4A3D-9EC3-168C45498AB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73219" y="1921746"/>
                      <a:ext cx="1983022" cy="1274315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5" name="직선 연결선 54">
                    <a:extLst>
                      <a:ext uri="{FF2B5EF4-FFF2-40B4-BE49-F238E27FC236}">
                        <a16:creationId xmlns:a16="http://schemas.microsoft.com/office/drawing/2014/main" id="{49CDCE0B-89DD-4A5B-95A5-DA0711495F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50792" y="302175"/>
                    <a:ext cx="1796082" cy="1036435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7" name="그룹 6">
                <a:extLst>
                  <a:ext uri="{FF2B5EF4-FFF2-40B4-BE49-F238E27FC236}">
                    <a16:creationId xmlns:a16="http://schemas.microsoft.com/office/drawing/2014/main" id="{1A33A25D-FF9E-43AB-8313-06BDC607A62C}"/>
                  </a:ext>
                </a:extLst>
              </p:cNvPr>
              <p:cNvGrpSpPr/>
              <p:nvPr/>
            </p:nvGrpSpPr>
            <p:grpSpPr>
              <a:xfrm>
                <a:off x="515253" y="3429917"/>
                <a:ext cx="5758220" cy="3083948"/>
                <a:chOff x="515253" y="3429917"/>
                <a:chExt cx="5758220" cy="3083948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3" y="3545704"/>
                  <a:ext cx="14927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0" name="그룹 59">
                  <a:extLst>
                    <a:ext uri="{FF2B5EF4-FFF2-40B4-BE49-F238E27FC236}">
                      <a16:creationId xmlns:a16="http://schemas.microsoft.com/office/drawing/2014/main" id="{70F94D43-B2C2-4275-8EFA-92A443D61E0F}"/>
                    </a:ext>
                  </a:extLst>
                </p:cNvPr>
                <p:cNvGrpSpPr/>
                <p:nvPr/>
              </p:nvGrpSpPr>
              <p:grpSpPr>
                <a:xfrm>
                  <a:off x="541937" y="3429917"/>
                  <a:ext cx="5731536" cy="3083948"/>
                  <a:chOff x="0" y="0"/>
                  <a:chExt cx="5720761" cy="2921032"/>
                </a:xfrm>
              </p:grpSpPr>
              <p:grpSp>
                <p:nvGrpSpPr>
                  <p:cNvPr id="61" name="그룹 60">
                    <a:extLst>
                      <a:ext uri="{FF2B5EF4-FFF2-40B4-BE49-F238E27FC236}">
                        <a16:creationId xmlns:a16="http://schemas.microsoft.com/office/drawing/2014/main" id="{84C58A3E-3456-4BCA-B307-D769AE0D5B3F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20761" cy="2921032"/>
                    <a:chOff x="0" y="0"/>
                    <a:chExt cx="5695116" cy="3251851"/>
                  </a:xfrm>
                </p:grpSpPr>
                <p:grpSp>
                  <p:nvGrpSpPr>
                    <p:cNvPr id="63" name="그룹 62">
                      <a:extLst>
                        <a:ext uri="{FF2B5EF4-FFF2-40B4-BE49-F238E27FC236}">
                          <a16:creationId xmlns:a16="http://schemas.microsoft.com/office/drawing/2014/main" id="{7FBB132B-4B28-46BA-B16C-166D14E3C55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695116" cy="3251851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65" name="차트 64">
                        <a:extLst>
                          <a:ext uri="{FF2B5EF4-FFF2-40B4-BE49-F238E27FC236}">
                            <a16:creationId xmlns:a16="http://schemas.microsoft.com/office/drawing/2014/main" id="{050DAF4D-BD24-40D5-A68A-3D833376CBC6}"/>
                          </a:ext>
                        </a:extLst>
                      </p:cNvPr>
                      <p:cNvGraphicFramePr>
                        <a:graphicFrameLocks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1485737720"/>
                          </p:ext>
                        </p:extLst>
                      </p:nvPr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graphicFrame>
                    <p:nvGraphicFramePr>
                      <p:cNvPr id="66" name="차트 65">
                        <a:extLst>
                          <a:ext uri="{FF2B5EF4-FFF2-40B4-BE49-F238E27FC236}">
                            <a16:creationId xmlns:a16="http://schemas.microsoft.com/office/drawing/2014/main" id="{CBB1D563-3066-4696-BEC5-CBA0EB3E0B1E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3" y="0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p:grpSp>
                <p:cxnSp>
                  <p:nvCxnSpPr>
                    <p:cNvPr id="64" name="직선 연결선 63">
                      <a:extLst>
                        <a:ext uri="{FF2B5EF4-FFF2-40B4-BE49-F238E27FC236}">
                          <a16:creationId xmlns:a16="http://schemas.microsoft.com/office/drawing/2014/main" id="{2C7AE998-572D-4652-957B-018FC8E1142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03648" y="1834078"/>
                      <a:ext cx="1794343" cy="106853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2" name="직선 연결선 61">
                    <a:extLst>
                      <a:ext uri="{FF2B5EF4-FFF2-40B4-BE49-F238E27FC236}">
                        <a16:creationId xmlns:a16="http://schemas.microsoft.com/office/drawing/2014/main" id="{362EDF6B-F911-4BDC-B275-B73AE58D4B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00250" y="373673"/>
                    <a:ext cx="1802423" cy="95982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" name="그룹 7">
                <a:extLst>
                  <a:ext uri="{FF2B5EF4-FFF2-40B4-BE49-F238E27FC236}">
                    <a16:creationId xmlns:a16="http://schemas.microsoft.com/office/drawing/2014/main" id="{4DE921A9-120B-449F-B1F3-41C19FE979E2}"/>
                  </a:ext>
                </a:extLst>
              </p:cNvPr>
              <p:cNvGrpSpPr/>
              <p:nvPr/>
            </p:nvGrpSpPr>
            <p:grpSpPr>
              <a:xfrm>
                <a:off x="518601" y="6480189"/>
                <a:ext cx="5744954" cy="2960341"/>
                <a:chOff x="518601" y="6480189"/>
                <a:chExt cx="5744954" cy="2960341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8601" y="6504288"/>
                  <a:ext cx="16417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7" name="그룹 66">
                  <a:extLst>
                    <a:ext uri="{FF2B5EF4-FFF2-40B4-BE49-F238E27FC236}">
                      <a16:creationId xmlns:a16="http://schemas.microsoft.com/office/drawing/2014/main" id="{026DC8C0-A0A1-4D88-9D9B-3E764277FD6D}"/>
                    </a:ext>
                  </a:extLst>
                </p:cNvPr>
                <p:cNvGrpSpPr/>
                <p:nvPr/>
              </p:nvGrpSpPr>
              <p:grpSpPr>
                <a:xfrm>
                  <a:off x="541937" y="6480189"/>
                  <a:ext cx="5721618" cy="2960341"/>
                  <a:chOff x="0" y="0"/>
                  <a:chExt cx="5708367" cy="3214577"/>
                </a:xfrm>
              </p:grpSpPr>
              <p:grpSp>
                <p:nvGrpSpPr>
                  <p:cNvPr id="68" name="그룹 67">
                    <a:extLst>
                      <a:ext uri="{FF2B5EF4-FFF2-40B4-BE49-F238E27FC236}">
                        <a16:creationId xmlns:a16="http://schemas.microsoft.com/office/drawing/2014/main" id="{E9952136-2F0F-4CDF-9713-6AF4E7D5D52A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71" name="차트 70">
                      <a:extLst>
                        <a:ext uri="{FF2B5EF4-FFF2-40B4-BE49-F238E27FC236}">
                          <a16:creationId xmlns:a16="http://schemas.microsoft.com/office/drawing/2014/main" id="{46A369A6-F590-4E19-8C56-7F35E2829412}"/>
                        </a:ext>
                      </a:extLst>
                    </p:cNvPr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251693266"/>
                        </p:ext>
                      </p:extLst>
                    </p:nvPr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72" name="차트 71">
                      <a:extLst>
                        <a:ext uri="{FF2B5EF4-FFF2-40B4-BE49-F238E27FC236}">
                          <a16:creationId xmlns:a16="http://schemas.microsoft.com/office/drawing/2014/main" id="{1F9AE09D-D943-4F91-87DB-1530CA5E82FD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69" name="직선 연결선 68">
                    <a:extLst>
                      <a:ext uri="{FF2B5EF4-FFF2-40B4-BE49-F238E27FC236}">
                        <a16:creationId xmlns:a16="http://schemas.microsoft.com/office/drawing/2014/main" id="{DF9B8018-CC61-41C7-A33D-D4C7B6785B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14619" y="319239"/>
                    <a:ext cx="1854063" cy="1240433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직선 연결선 69">
                    <a:extLst>
                      <a:ext uri="{FF2B5EF4-FFF2-40B4-BE49-F238E27FC236}">
                        <a16:creationId xmlns:a16="http://schemas.microsoft.com/office/drawing/2014/main" id="{2AABA906-CD88-4056-92F5-E419608B05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27840" y="1717964"/>
                    <a:ext cx="1864229" cy="1172809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3520670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4</TotalTime>
  <Words>85</Words>
  <Application>Microsoft Office PowerPoint</Application>
  <PresentationFormat>A4 용지(210x297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29</cp:revision>
  <dcterms:created xsi:type="dcterms:W3CDTF">2024-07-11T07:58:49Z</dcterms:created>
  <dcterms:modified xsi:type="dcterms:W3CDTF">2025-09-25T00:26:57Z</dcterms:modified>
</cp:coreProperties>
</file>